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3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6/02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23359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2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2/2018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2/2018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2/2018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2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6/02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6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(www.imi-summit.eu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32552" y="5622339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Colhoun and </a:t>
            </a:r>
            <a:r>
              <a:rPr lang="en-GB" dirty="0" err="1"/>
              <a:t>Marchovecchio</a:t>
            </a:r>
            <a:r>
              <a:rPr lang="en-GB" dirty="0"/>
              <a:t> Diabetologia DOI 10.1007/s00125-018-4567-5 </a:t>
            </a:r>
          </a:p>
          <a:p>
            <a:r>
              <a:rPr lang="en-GB" sz="1200" dirty="0"/>
              <a:t>© The Authors (2018) Distributed under the terms of the CC BY 4.0 Attribution License (http://creativecommons.org/licenses/by/4.0/)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resumed site of origin of commonly associated biomarkers predictive of DKD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36BCCB3-F3DB-4D47-8069-08CC89CFF4E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07704" y="822593"/>
            <a:ext cx="5328592" cy="50756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5581689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Colhoun and </a:t>
            </a:r>
            <a:r>
              <a:rPr lang="en-GB" dirty="0" err="1"/>
              <a:t>Marchovecchio</a:t>
            </a:r>
            <a:r>
              <a:rPr lang="en-GB" dirty="0"/>
              <a:t> Diabetologia DOI 10.1007/s00125-018-4567-5 </a:t>
            </a:r>
          </a:p>
          <a:p>
            <a:r>
              <a:rPr lang="en-GB" sz="1200" dirty="0"/>
              <a:t>© The Authors (2018) Distributed under the terms of the CC BY 4.0 Attribution License (http://creativecommons.org/licenses/by/4.0/)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Correlation matrix of biomarker measures in the SUMMIT project </a:t>
            </a:r>
            <a:r>
              <a:rPr lang="en-GB" b="1" u="sng" dirty="0">
                <a:hlinkClick r:id="rId4"/>
              </a:rPr>
              <a:t>(www.imi-summit.eu/</a:t>
            </a:r>
            <a:r>
              <a:rPr lang="en-GB" b="1" dirty="0"/>
              <a:t>) showing there is high correlation between biomarkers that are of interest because of different pathway involvement</a:t>
            </a:r>
            <a:endParaRPr lang="en-GB" sz="20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5A45224-E321-4D85-9D5C-25757FD49EB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86550" y="1124744"/>
            <a:ext cx="5005730" cy="4824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41980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7</TotalTime>
  <Words>121</Words>
  <Application>Microsoft Office PowerPoint</Application>
  <PresentationFormat>On-screen Show (4:3)</PresentationFormat>
  <Paragraphs>1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Shelley Williams</cp:lastModifiedBy>
  <cp:revision>31</cp:revision>
  <dcterms:created xsi:type="dcterms:W3CDTF">2016-06-15T12:53:43Z</dcterms:created>
  <dcterms:modified xsi:type="dcterms:W3CDTF">2018-02-16T11:15:04Z</dcterms:modified>
</cp:coreProperties>
</file>